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D5B16-57C6-4E83-A5D3-B6A556283D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B137D6-8E25-417D-9581-94583FFA1B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F68013-41A3-4AEE-B0D9-D8780BA6A9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E25457-1096-4634-A47B-ECB8E95F10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0647A1-F16F-40F8-8A8F-E13514EB47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5CAC4-6DBE-4CB5-93EF-CEC5548DA2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78F81-3330-451C-A738-B80CAD0BB1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ECDD9B-22B0-44EA-A1F7-B02C5344AC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41D0D-8DAA-43C3-85D2-3CD67F87DD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C70B3-A166-4D4F-9AF3-BB7F8B9CD2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662CC-7939-4A08-8092-F6DC904921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98A53-7ACB-484A-9243-AB779AA0B5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DAEF47-AF75-4FE6-A615-628900B03A1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3" descr=""/>
          <p:cNvPicPr/>
          <p:nvPr/>
        </p:nvPicPr>
        <p:blipFill>
          <a:blip r:embed="rId1"/>
          <a:stretch/>
        </p:blipFill>
        <p:spPr>
          <a:xfrm>
            <a:off x="0" y="115920"/>
            <a:ext cx="8967960" cy="59068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2" name=""/>
          <p:cNvGraphicFramePr/>
          <p:nvPr/>
        </p:nvGraphicFramePr>
        <p:xfrm>
          <a:off x="4716360" y="260280"/>
          <a:ext cx="3816360" cy="3224160"/>
        </p:xfrm>
        <a:graphic>
          <a:graphicData uri="http://schemas.openxmlformats.org/drawingml/2006/table">
            <a:tbl>
              <a:tblPr/>
              <a:tblGrid>
                <a:gridCol w="1136880"/>
                <a:gridCol w="892080"/>
                <a:gridCol w="1787400"/>
              </a:tblGrid>
              <a:tr h="436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peci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ultiplicit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stimated genome size (base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2212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. × ananass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16,715,68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dcdb"/>
                    </a:solidFill>
                  </a:tcPr>
                </a:tc>
              </a:tr>
              <a:tr h="277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9969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92,093,56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99694"/>
                    </a:solidFill>
                  </a:tcPr>
                </a:tc>
              </a:tr>
              <a:tr h="22212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. iinum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5,410,20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</a:tr>
              <a:tr h="223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93cddd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0,643,759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93cddd"/>
                    </a:solidFill>
                  </a:tcPr>
                </a:tc>
              </a:tr>
              <a:tr h="22212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. nipponic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bf1de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bf1de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5,755,72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bf1de"/>
                    </a:solidFill>
                  </a:tcPr>
                </a:tc>
              </a:tr>
              <a:tr h="281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7,791,858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92d050"/>
                    </a:solidFill>
                  </a:tcPr>
                </a:tc>
              </a:tr>
              <a:tr h="22392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. nubicol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8,479,99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cc"/>
                    </a:solidFill>
                  </a:tcPr>
                </a:tc>
              </a:tr>
              <a:tr h="222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1,950,744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c000"/>
                    </a:solidFill>
                  </a:tcPr>
                </a:tc>
              </a:tr>
              <a:tr h="222120">
                <a:tc rowSpan="4"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. orientali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6e0ec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6e0ec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718,142,61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6e0ec"/>
                    </a:solidFill>
                  </a:tcPr>
                </a:tc>
              </a:tr>
              <a:tr h="223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6e0ec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225,829,02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6e0ec"/>
                    </a:solidFill>
                  </a:tcPr>
                </a:tc>
              </a:tr>
              <a:tr h="222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b3a2c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9,258,548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b3a2c7"/>
                    </a:solidFill>
                  </a:tcPr>
                </a:tc>
              </a:tr>
              <a:tr h="223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6e0ec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4,757,88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6e0ec"/>
                    </a:solidFill>
                  </a:tcPr>
                </a:tc>
              </a:tr>
            </a:tbl>
          </a:graphicData>
        </a:graphic>
      </p:graphicFrame>
      <p:sp>
        <p:nvSpPr>
          <p:cNvPr id="43" name="正方形/長方形 5"/>
          <p:cNvSpPr/>
          <p:nvPr/>
        </p:nvSpPr>
        <p:spPr>
          <a:xfrm>
            <a:off x="684360" y="6165720"/>
            <a:ext cx="7848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Supplemental Figure S2: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 Distribution of the number of distinct kmers (kmer = 17) with the given multiplicity values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05T13:06:50Z</dcterms:created>
  <dc:creator>Hideki Hirakawa</dc:creator>
  <dc:description/>
  <dc:language>en-US</dc:language>
  <cp:lastModifiedBy>Sachiko Isobe</cp:lastModifiedBy>
  <dcterms:modified xsi:type="dcterms:W3CDTF">2013-09-05T07:53:11Z</dcterms:modified>
  <cp:revision>14</cp:revision>
  <dc:subject/>
  <dc:title>PowerPoint プレゼンテーション</dc:title>
</cp:coreProperties>
</file>